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4" d="100"/>
          <a:sy n="74" d="100"/>
        </p:scale>
        <p:origin x="936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E23CA-6AEA-4908-ABDF-E7A3A1416A8F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33E5B-6D30-4A3A-A779-35B462E51DA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06220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E23CA-6AEA-4908-ABDF-E7A3A1416A8F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33E5B-6D30-4A3A-A779-35B462E51DA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79720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E23CA-6AEA-4908-ABDF-E7A3A1416A8F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33E5B-6D30-4A3A-A779-35B462E51DA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12008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E23CA-6AEA-4908-ABDF-E7A3A1416A8F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33E5B-6D30-4A3A-A779-35B462E51DA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97632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E23CA-6AEA-4908-ABDF-E7A3A1416A8F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33E5B-6D30-4A3A-A779-35B462E51DA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19744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E23CA-6AEA-4908-ABDF-E7A3A1416A8F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33E5B-6D30-4A3A-A779-35B462E51DA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27806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E23CA-6AEA-4908-ABDF-E7A3A1416A8F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33E5B-6D30-4A3A-A779-35B462E51DA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77258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E23CA-6AEA-4908-ABDF-E7A3A1416A8F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33E5B-6D30-4A3A-A779-35B462E51DA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8824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E23CA-6AEA-4908-ABDF-E7A3A1416A8F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33E5B-6D30-4A3A-A779-35B462E51DA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87301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E23CA-6AEA-4908-ABDF-E7A3A1416A8F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33E5B-6D30-4A3A-A779-35B462E51DA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78671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E23CA-6AEA-4908-ABDF-E7A3A1416A8F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33E5B-6D30-4A3A-A779-35B462E51DA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93498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3E23CA-6AEA-4908-ABDF-E7A3A1416A8F}" type="datetimeFigureOut">
              <a:rPr lang="en-GB" smtClean="0"/>
              <a:t>20/02/2026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433E5B-6D30-4A3A-A779-35B462E51DA2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40483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a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79864595"/>
              </p:ext>
            </p:extLst>
          </p:nvPr>
        </p:nvGraphicFramePr>
        <p:xfrm>
          <a:off x="601712" y="4830286"/>
          <a:ext cx="10755550" cy="1026160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2151110">
                  <a:extLst>
                    <a:ext uri="{9D8B030D-6E8A-4147-A177-3AD203B41FA5}">
                      <a16:colId xmlns:a16="http://schemas.microsoft.com/office/drawing/2014/main" val="1709427174"/>
                    </a:ext>
                  </a:extLst>
                </a:gridCol>
                <a:gridCol w="2151110">
                  <a:extLst>
                    <a:ext uri="{9D8B030D-6E8A-4147-A177-3AD203B41FA5}">
                      <a16:colId xmlns:a16="http://schemas.microsoft.com/office/drawing/2014/main" val="2532100176"/>
                    </a:ext>
                  </a:extLst>
                </a:gridCol>
                <a:gridCol w="2151110">
                  <a:extLst>
                    <a:ext uri="{9D8B030D-6E8A-4147-A177-3AD203B41FA5}">
                      <a16:colId xmlns:a16="http://schemas.microsoft.com/office/drawing/2014/main" val="2559418456"/>
                    </a:ext>
                  </a:extLst>
                </a:gridCol>
                <a:gridCol w="2151110">
                  <a:extLst>
                    <a:ext uri="{9D8B030D-6E8A-4147-A177-3AD203B41FA5}">
                      <a16:colId xmlns:a16="http://schemas.microsoft.com/office/drawing/2014/main" val="234057612"/>
                    </a:ext>
                  </a:extLst>
                </a:gridCol>
                <a:gridCol w="2151110">
                  <a:extLst>
                    <a:ext uri="{9D8B030D-6E8A-4147-A177-3AD203B41FA5}">
                      <a16:colId xmlns:a16="http://schemas.microsoft.com/office/drawing/2014/main" val="303666753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h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 coefficient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d. Error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% CI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954474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s ← Income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72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66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0.0447, 0.1097]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1229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R ← METs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7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4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0.0009, 0.0025]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6242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R ← Income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4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1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3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[0.0001, 0.0007]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19948941"/>
                  </a:ext>
                </a:extLst>
              </a:tr>
            </a:tbl>
          </a:graphicData>
        </a:graphic>
      </p:graphicFrame>
      <p:graphicFrame>
        <p:nvGraphicFramePr>
          <p:cNvPr id="5" name="Tabla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60300598"/>
              </p:ext>
            </p:extLst>
          </p:nvPr>
        </p:nvGraphicFramePr>
        <p:xfrm>
          <a:off x="601714" y="1998801"/>
          <a:ext cx="10755548" cy="1539240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2688887">
                  <a:extLst>
                    <a:ext uri="{9D8B030D-6E8A-4147-A177-3AD203B41FA5}">
                      <a16:colId xmlns:a16="http://schemas.microsoft.com/office/drawing/2014/main" val="296358526"/>
                    </a:ext>
                  </a:extLst>
                </a:gridCol>
                <a:gridCol w="2688887">
                  <a:extLst>
                    <a:ext uri="{9D8B030D-6E8A-4147-A177-3AD203B41FA5}">
                      <a16:colId xmlns:a16="http://schemas.microsoft.com/office/drawing/2014/main" val="4294836420"/>
                    </a:ext>
                  </a:extLst>
                </a:gridCol>
                <a:gridCol w="2688887">
                  <a:extLst>
                    <a:ext uri="{9D8B030D-6E8A-4147-A177-3AD203B41FA5}">
                      <a16:colId xmlns:a16="http://schemas.microsoft.com/office/drawing/2014/main" val="2350960547"/>
                    </a:ext>
                  </a:extLst>
                </a:gridCol>
                <a:gridCol w="2688887">
                  <a:extLst>
                    <a:ext uri="{9D8B030D-6E8A-4147-A177-3AD203B41FA5}">
                      <a16:colId xmlns:a16="http://schemas.microsoft.com/office/drawing/2014/main" val="1044172808"/>
                    </a:ext>
                  </a:extLst>
                </a:gridCol>
              </a:tblGrid>
              <a:tr h="23733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ffect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stimate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-value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2394504"/>
                  </a:ext>
                </a:extLst>
              </a:tr>
              <a:tr h="23733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irect effect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6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01917450"/>
                  </a:ext>
                </a:extLst>
              </a:tr>
              <a:tr h="23733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rect effect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21427202"/>
                  </a:ext>
                </a:extLst>
              </a:tr>
              <a:tr h="23733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effect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01562113"/>
                  </a:ext>
                </a:extLst>
              </a:tr>
              <a:tr h="23733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portion mediated (RIT)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%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64250372"/>
                  </a:ext>
                </a:extLst>
              </a:tr>
              <a:tr h="23733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irect/Direct (RID)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06</a:t>
                      </a:r>
                      <a:endParaRPr lang="en-GB" sz="160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GB" sz="1600" dirty="0">
                        <a:effectLst/>
                        <a:latin typeface="Arial" panose="020B0604020202020204" pitchFamily="34" charset="0"/>
                        <a:ea typeface="MS Mincho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01659322"/>
                  </a:ext>
                </a:extLst>
              </a:tr>
            </a:tbl>
          </a:graphicData>
        </a:graphic>
      </p:graphicFrame>
      <p:sp>
        <p:nvSpPr>
          <p:cNvPr id="7" name="Rectángulo 6"/>
          <p:cNvSpPr/>
          <p:nvPr/>
        </p:nvSpPr>
        <p:spPr>
          <a:xfrm>
            <a:off x="601714" y="1246199"/>
            <a:ext cx="424988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b="1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A. Structural Equation Model Results</a:t>
            </a:r>
          </a:p>
        </p:txBody>
      </p:sp>
      <p:sp>
        <p:nvSpPr>
          <p:cNvPr id="8" name="Rectángulo 7"/>
          <p:cNvSpPr/>
          <p:nvPr/>
        </p:nvSpPr>
        <p:spPr>
          <a:xfrm>
            <a:off x="601714" y="4454396"/>
            <a:ext cx="59853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b="1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B. Mediation Analysis Summary (</a:t>
            </a:r>
            <a:r>
              <a:rPr lang="en-US" altLang="en-US" b="1" dirty="0" err="1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medsem</a:t>
            </a:r>
            <a:r>
              <a:rPr lang="en-US" altLang="en-US" b="1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 command)</a:t>
            </a:r>
          </a:p>
        </p:txBody>
      </p:sp>
      <p:sp>
        <p:nvSpPr>
          <p:cNvPr id="9" name="CuadroTexto 8"/>
          <p:cNvSpPr txBox="1"/>
          <p:nvPr/>
        </p:nvSpPr>
        <p:spPr>
          <a:xfrm>
            <a:off x="601714" y="302373"/>
            <a:ext cx="1100493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err="1" smtClean="0"/>
              <a:t>Supplementary</a:t>
            </a:r>
            <a:r>
              <a:rPr lang="es-ES" b="1" dirty="0" smtClean="0"/>
              <a:t> Material S2 </a:t>
            </a:r>
            <a:r>
              <a:rPr lang="en-US" dirty="0"/>
              <a:t>Four-way decomposition and mediation analyses of the association between income and </a:t>
            </a:r>
            <a:r>
              <a:rPr lang="en-US" dirty="0" err="1"/>
              <a:t>glycaemic</a:t>
            </a:r>
            <a:r>
              <a:rPr lang="en-US"/>
              <a:t> contro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3767077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01</Words>
  <Application>Microsoft Office PowerPoint</Application>
  <PresentationFormat>Panorámica</PresentationFormat>
  <Paragraphs>47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MS Gothic</vt:lpstr>
      <vt:lpstr>Arial</vt:lpstr>
      <vt:lpstr>Calibri</vt:lpstr>
      <vt:lpstr>Calibri Light</vt:lpstr>
      <vt:lpstr>MS Mincho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ernando</dc:creator>
  <cp:lastModifiedBy>Fernando</cp:lastModifiedBy>
  <cp:revision>5</cp:revision>
  <dcterms:created xsi:type="dcterms:W3CDTF">2025-07-22T13:12:41Z</dcterms:created>
  <dcterms:modified xsi:type="dcterms:W3CDTF">2026-02-20T10:38:22Z</dcterms:modified>
</cp:coreProperties>
</file>